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8" r:id="rId2"/>
    <p:sldId id="264" r:id="rId3"/>
    <p:sldId id="272" r:id="rId4"/>
    <p:sldId id="271" r:id="rId5"/>
    <p:sldId id="277" r:id="rId6"/>
    <p:sldId id="274" r:id="rId7"/>
    <p:sldId id="267" r:id="rId8"/>
    <p:sldId id="279" r:id="rId9"/>
    <p:sldId id="275" r:id="rId10"/>
    <p:sldId id="276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 Figures" id="{5B742A8E-5056-4B00-BA1E-9DFB816CED57}">
          <p14:sldIdLst>
            <p14:sldId id="278"/>
            <p14:sldId id="264"/>
            <p14:sldId id="272"/>
            <p14:sldId id="271"/>
            <p14:sldId id="277"/>
            <p14:sldId id="274"/>
            <p14:sldId id="267"/>
            <p14:sldId id="279"/>
            <p14:sldId id="275"/>
            <p14:sldId id="27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792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678" y="78"/>
      </p:cViewPr>
      <p:guideLst>
        <p:guide orient="horz" pos="379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B357C1-BE1B-4891-9021-95A9C964DF40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BC1CB3-0692-47A1-8FE3-A4214D110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468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BC1CB3-0692-47A1-8FE3-A4214D110E5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033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BC1CB3-0692-47A1-8FE3-A4214D110E50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4173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24271B-405F-49B1-BEB1-9BA16AD7E1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164520A-E9C8-476B-8287-637FEDAD0E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D5670F-7BFA-491D-BB0C-0D84F28DD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F229A0-7AB2-4F76-825C-852488CEA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3B534E-5B60-4663-AC7E-CE055292B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82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FC7611-26E6-476B-93AF-B7D6B53160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0350F50-2521-457A-AA8E-C824EDE878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32D2B3-3A14-4174-BA10-8E22FB8B3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768966-328F-4678-8781-D803635C3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9DBD20-36A4-4F94-B7B7-18F9C4346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159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7E1F923-21A6-450C-922F-2AE155917A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4AD6947-8516-4D3E-A6A5-33886C72A5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34791B-F771-422A-A3F4-5510B5C07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761759-7D5E-427D-8854-04B14A454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C6A49C-CC84-4595-91BC-F1076D898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592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B5AB-BAAC-422D-BAA1-53DC19223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91F412-D3B8-4838-9B1E-817008B6BA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92BD9A-90F0-4831-9258-C3664C3B9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DC0995-9103-42C5-9578-33F253F0A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F60960-CD83-465B-9860-12ADFFA6A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090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44ED09-A616-42C1-976A-7A8A81BA19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7EAC7D-ABF5-42FC-B147-3D13E8E7DD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457C85-83B9-429E-9594-AE8E3DF8F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70B069-30E0-4521-84BB-4027DB8DA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E86F1F-383E-4BF6-BD9D-FCEBDFF84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114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23F571-720B-4342-85FF-4879166D61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5EEFA5-88B2-47BB-ABD3-3A4396C64A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D935867-60C8-4604-AEE9-6267CCC215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330C62A-080B-463F-9415-D05AE0553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D161F12-0C79-41A8-9715-99761F7F4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994646-BB2C-4AE2-B233-C3F836857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94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056692-3945-403B-8FCA-166D6CF37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4539267-5FC5-4BA7-89CB-0B9C942A23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04458C4-C9A1-466E-990A-61BCF5B2F4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C2B0ADE-7222-4CED-91E7-75F289AA99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6FE1A1D-BE51-4957-A3B8-7B4BD50D9B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9472547-BD32-4FF8-95F7-18C665ECC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99CB5A3-86D3-4948-9089-68500C2C6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7521EF1-9B18-42A2-B357-62A838EA6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141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B08E00-2322-4F8C-B025-D66E34C18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5B6FC13-7E01-402E-9D05-239197B32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01E4F8E-D0D6-4AF7-BA6F-AAFB897F3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5A7F660-A758-4501-9FE9-9C3C3F6AE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284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C8D69D2-C0FF-4F85-8AC7-A8E9A185B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A57CEA6-193A-4C35-964B-9BF1CAB76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F50177B-5C4A-4721-96B4-A798337CC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982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BCB5A5-9521-4188-BD73-9FE14407E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352A96-112E-4433-9A2F-0AACE6E39A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4619231-813B-4CB6-BABA-CFCF79823B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9E30C31-5EEC-4123-B11B-8AA0D8085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BBB246-8F72-47F9-A63B-8D9F5D351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8742BD5-1228-450D-89F7-40C434DC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82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45BC63-6383-41BB-B57F-BCF1414F3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36E1B3F-2D34-46D7-8EA0-E6506DC19E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446C783-C6B5-40E2-8A79-9DC4DAB087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E2F2A0B-3BE7-4DE2-B175-932316438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72DB100-696B-4B09-B441-D2CB4A48D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1BD335B-93EB-4DC2-B335-F5AC392AB6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367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EE8B58F-3C55-4AB1-B7D0-F1A5021D2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A546583-1BBF-4A7F-B55D-2FC09B5163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9C18B0-6018-4072-A180-51E2FE22FB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23770-ABC6-4BF0-A13E-B3F8F5EC97B1}" type="datetimeFigureOut">
              <a:rPr lang="en-US" smtClean="0"/>
              <a:t>12/18/2021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4D57E6-D11E-410E-8630-C2C617E4A7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172AB2-1F00-4BA5-B4F3-F6F698D7BF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27308-483A-4030-9733-2A5457BD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780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eg"/><Relationship Id="rId5" Type="http://schemas.openxmlformats.org/officeDocument/2006/relationships/image" Target="../media/image17.jpeg"/><Relationship Id="rId4" Type="http://schemas.openxmlformats.org/officeDocument/2006/relationships/image" Target="../media/image16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tif"/><Relationship Id="rId4" Type="http://schemas.openxmlformats.org/officeDocument/2006/relationships/image" Target="../media/image12.ti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770E8F7-FDFC-4C99-802B-F44CC1B752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88830" y="0"/>
            <a:ext cx="8655353" cy="6858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9CF7FB3-D52B-463C-9C30-074DF69E5926}"/>
              </a:ext>
            </a:extLst>
          </p:cNvPr>
          <p:cNvSpPr txBox="1"/>
          <p:nvPr/>
        </p:nvSpPr>
        <p:spPr>
          <a:xfrm>
            <a:off x="0" y="6397625"/>
            <a:ext cx="29651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8798284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E700619-73CD-481B-91C0-C27E97DFAF0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605" b="2136"/>
          <a:stretch/>
        </p:blipFill>
        <p:spPr>
          <a:xfrm>
            <a:off x="2652640" y="1134145"/>
            <a:ext cx="6296470" cy="475488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42F1DBA-E66B-457D-9FD3-F6F625E7A10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51" t="4919" r="28051"/>
          <a:stretch/>
        </p:blipFill>
        <p:spPr>
          <a:xfrm>
            <a:off x="44390" y="33316"/>
            <a:ext cx="2560320" cy="276960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DEA2717-A2DF-4B40-B0A1-4DC2516C702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75" r="15623"/>
          <a:stretch/>
        </p:blipFill>
        <p:spPr>
          <a:xfrm>
            <a:off x="8975617" y="19951"/>
            <a:ext cx="3200400" cy="291870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82F31370-93C3-479D-BFBA-7D47EA2F8E9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586812" y="3588772"/>
            <a:ext cx="3840480" cy="256032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B2319093-5CE7-41CE-A7C2-85C81080D4B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2722" y="4649069"/>
            <a:ext cx="3200400" cy="21336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365A22A2-274D-4648-B22C-5816082288B9}"/>
              </a:ext>
            </a:extLst>
          </p:cNvPr>
          <p:cNvSpPr txBox="1"/>
          <p:nvPr/>
        </p:nvSpPr>
        <p:spPr>
          <a:xfrm>
            <a:off x="3209279" y="5889025"/>
            <a:ext cx="5468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BE7.10n                                       Jin668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椭圆 16">
            <a:extLst>
              <a:ext uri="{FF2B5EF4-FFF2-40B4-BE49-F238E27FC236}">
                <a16:creationId xmlns:a16="http://schemas.microsoft.com/office/drawing/2014/main" id="{4874782E-98E2-4F95-A72D-C4777D08EB1D}"/>
              </a:ext>
            </a:extLst>
          </p:cNvPr>
          <p:cNvSpPr/>
          <p:nvPr/>
        </p:nvSpPr>
        <p:spPr>
          <a:xfrm>
            <a:off x="3209279" y="1793289"/>
            <a:ext cx="1722268" cy="1715610"/>
          </a:xfrm>
          <a:prstGeom prst="ellipse">
            <a:avLst/>
          </a:prstGeom>
          <a:noFill/>
          <a:ln w="3810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椭圆 18">
            <a:extLst>
              <a:ext uri="{FF2B5EF4-FFF2-40B4-BE49-F238E27FC236}">
                <a16:creationId xmlns:a16="http://schemas.microsoft.com/office/drawing/2014/main" id="{1F6330F0-8988-4672-B67D-D62493740C30}"/>
              </a:ext>
            </a:extLst>
          </p:cNvPr>
          <p:cNvSpPr/>
          <p:nvPr/>
        </p:nvSpPr>
        <p:spPr>
          <a:xfrm>
            <a:off x="5943601" y="1359589"/>
            <a:ext cx="1920536" cy="2069411"/>
          </a:xfrm>
          <a:prstGeom prst="ellipse">
            <a:avLst/>
          </a:prstGeom>
          <a:noFill/>
          <a:ln w="3810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9A8DA3AF-0D22-479C-9F70-1BDE1418C928}"/>
              </a:ext>
            </a:extLst>
          </p:cNvPr>
          <p:cNvCxnSpPr>
            <a:cxnSpLocks/>
            <a:endCxn id="7" idx="3"/>
          </p:cNvCxnSpPr>
          <p:nvPr/>
        </p:nvCxnSpPr>
        <p:spPr>
          <a:xfrm flipH="1" flipV="1">
            <a:off x="2604710" y="1418119"/>
            <a:ext cx="697784" cy="881200"/>
          </a:xfrm>
          <a:prstGeom prst="straightConnector1">
            <a:avLst/>
          </a:prstGeom>
          <a:ln w="38100">
            <a:solidFill>
              <a:srgbClr val="C0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E0BD1D00-C285-4DAF-8EEA-C5ABC1337316}"/>
              </a:ext>
            </a:extLst>
          </p:cNvPr>
          <p:cNvCxnSpPr>
            <a:cxnSpLocks/>
            <a:endCxn id="9" idx="1"/>
          </p:cNvCxnSpPr>
          <p:nvPr/>
        </p:nvCxnSpPr>
        <p:spPr>
          <a:xfrm flipV="1">
            <a:off x="7881766" y="1479304"/>
            <a:ext cx="1093851" cy="820016"/>
          </a:xfrm>
          <a:prstGeom prst="straightConnector1">
            <a:avLst/>
          </a:prstGeom>
          <a:ln w="38100">
            <a:solidFill>
              <a:srgbClr val="C0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椭圆 27">
            <a:extLst>
              <a:ext uri="{FF2B5EF4-FFF2-40B4-BE49-F238E27FC236}">
                <a16:creationId xmlns:a16="http://schemas.microsoft.com/office/drawing/2014/main" id="{18660BAE-30EA-4609-8050-C6D0D6BA08E8}"/>
              </a:ext>
            </a:extLst>
          </p:cNvPr>
          <p:cNvSpPr/>
          <p:nvPr/>
        </p:nvSpPr>
        <p:spPr>
          <a:xfrm>
            <a:off x="2618029" y="3963676"/>
            <a:ext cx="870896" cy="1219371"/>
          </a:xfrm>
          <a:prstGeom prst="ellipse">
            <a:avLst/>
          </a:prstGeom>
          <a:noFill/>
          <a:ln w="38100">
            <a:solidFill>
              <a:srgbClr val="FFC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椭圆 29">
            <a:extLst>
              <a:ext uri="{FF2B5EF4-FFF2-40B4-BE49-F238E27FC236}">
                <a16:creationId xmlns:a16="http://schemas.microsoft.com/office/drawing/2014/main" id="{5947904B-73B4-4C8E-AEAB-D69927DED301}"/>
              </a:ext>
            </a:extLst>
          </p:cNvPr>
          <p:cNvSpPr/>
          <p:nvPr/>
        </p:nvSpPr>
        <p:spPr>
          <a:xfrm rot="20419054">
            <a:off x="6723456" y="3490054"/>
            <a:ext cx="2211502" cy="1590776"/>
          </a:xfrm>
          <a:prstGeom prst="ellipse">
            <a:avLst/>
          </a:prstGeom>
          <a:noFill/>
          <a:ln w="38100">
            <a:solidFill>
              <a:srgbClr val="FFC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A3BDFE54-7D4C-4AA3-91D7-0E11015B39CC}"/>
              </a:ext>
            </a:extLst>
          </p:cNvPr>
          <p:cNvCxnSpPr>
            <a:cxnSpLocks/>
          </p:cNvCxnSpPr>
          <p:nvPr/>
        </p:nvCxnSpPr>
        <p:spPr>
          <a:xfrm flipH="1">
            <a:off x="2604711" y="5086905"/>
            <a:ext cx="245021" cy="352976"/>
          </a:xfrm>
          <a:prstGeom prst="straightConnector1">
            <a:avLst/>
          </a:prstGeom>
          <a:ln w="38100">
            <a:solidFill>
              <a:srgbClr val="FFC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A2C09093-5CC2-4C56-84C7-30BB9005A683}"/>
              </a:ext>
            </a:extLst>
          </p:cNvPr>
          <p:cNvCxnSpPr>
            <a:cxnSpLocks/>
            <a:endCxn id="15" idx="1"/>
          </p:cNvCxnSpPr>
          <p:nvPr/>
        </p:nvCxnSpPr>
        <p:spPr>
          <a:xfrm>
            <a:off x="8283398" y="4983369"/>
            <a:ext cx="699324" cy="732500"/>
          </a:xfrm>
          <a:prstGeom prst="straightConnector1">
            <a:avLst/>
          </a:prstGeom>
          <a:ln w="38100">
            <a:solidFill>
              <a:srgbClr val="FFC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9DFFE8FE-272A-413B-8ACD-6E6A6F9426D2}"/>
              </a:ext>
            </a:extLst>
          </p:cNvPr>
          <p:cNvSpPr txBox="1"/>
          <p:nvPr/>
        </p:nvSpPr>
        <p:spPr>
          <a:xfrm>
            <a:off x="4261280" y="6431513"/>
            <a:ext cx="29562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</a:t>
            </a:r>
            <a:r>
              <a:rPr lang="en-US" altLang="zh-CN" sz="2400">
                <a:latin typeface="Times New Roman" panose="02020603050405020304" charset="0"/>
                <a:cs typeface="Times New Roman" panose="02020603050405020304" charset="0"/>
              </a:rPr>
              <a:t>S10</a:t>
            </a:r>
            <a:endParaRPr lang="en-US" altLang="zh-CN" sz="2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8263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9B7B195-DBA2-449D-B490-D973D6548F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7" t="16793" r="4422"/>
          <a:stretch/>
        </p:blipFill>
        <p:spPr>
          <a:xfrm>
            <a:off x="139454" y="222663"/>
            <a:ext cx="11913092" cy="641267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8DF5BC0-D2BF-4214-8AD5-5D72867A363E}"/>
              </a:ext>
            </a:extLst>
          </p:cNvPr>
          <p:cNvSpPr txBox="1"/>
          <p:nvPr/>
        </p:nvSpPr>
        <p:spPr>
          <a:xfrm>
            <a:off x="0" y="6397625"/>
            <a:ext cx="31160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29870455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63C3526-C7F0-4BD3-B432-7D566DC9B7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927114"/>
            <a:ext cx="6037771" cy="459479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AE3150F-3281-4145-BB8A-44E2782B24C8}"/>
              </a:ext>
            </a:extLst>
          </p:cNvPr>
          <p:cNvSpPr txBox="1"/>
          <p:nvPr/>
        </p:nvSpPr>
        <p:spPr>
          <a:xfrm>
            <a:off x="0" y="6397625"/>
            <a:ext cx="29740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3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543D821-22BD-4DA4-B27B-45BC9F5D5E1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939" y="1297944"/>
            <a:ext cx="6051416" cy="336283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93CFAA0-E694-47EE-9D7B-7F362DF6A16B}"/>
              </a:ext>
            </a:extLst>
          </p:cNvPr>
          <p:cNvSpPr txBox="1"/>
          <p:nvPr/>
        </p:nvSpPr>
        <p:spPr>
          <a:xfrm>
            <a:off x="0" y="5577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303DE2A-32A2-4C75-863B-D950F0D6A571}"/>
              </a:ext>
            </a:extLst>
          </p:cNvPr>
          <p:cNvSpPr txBox="1"/>
          <p:nvPr/>
        </p:nvSpPr>
        <p:spPr>
          <a:xfrm>
            <a:off x="6154231" y="55778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92564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8A0EBC54-46DC-4870-9E1E-F8E5C27637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862" y="429478"/>
            <a:ext cx="11124138" cy="642852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A1D0098-0A79-4AE9-9658-8C803FBA1ED9}"/>
              </a:ext>
            </a:extLst>
          </p:cNvPr>
          <p:cNvSpPr txBox="1"/>
          <p:nvPr/>
        </p:nvSpPr>
        <p:spPr>
          <a:xfrm>
            <a:off x="0" y="6397625"/>
            <a:ext cx="30450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4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08398B12-54FA-4122-A3D9-E03EEC0C4696}"/>
              </a:ext>
            </a:extLst>
          </p:cNvPr>
          <p:cNvSpPr/>
          <p:nvPr/>
        </p:nvSpPr>
        <p:spPr>
          <a:xfrm>
            <a:off x="1748901" y="399495"/>
            <a:ext cx="861134" cy="53552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ABA827C-610B-4E36-A167-A169E493E843}"/>
              </a:ext>
            </a:extLst>
          </p:cNvPr>
          <p:cNvSpPr txBox="1"/>
          <p:nvPr/>
        </p:nvSpPr>
        <p:spPr>
          <a:xfrm>
            <a:off x="4061479" y="95081"/>
            <a:ext cx="1038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RNA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83BF025E-F125-4CF1-BFB0-480DE46AEB0B}"/>
              </a:ext>
            </a:extLst>
          </p:cNvPr>
          <p:cNvCxnSpPr>
            <a:cxnSpLocks/>
          </p:cNvCxnSpPr>
          <p:nvPr/>
        </p:nvCxnSpPr>
        <p:spPr>
          <a:xfrm>
            <a:off x="1740025" y="445181"/>
            <a:ext cx="5681707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3FBB93AF-0A08-4C6D-ADA8-9FD0A40CC5F5}"/>
              </a:ext>
            </a:extLst>
          </p:cNvPr>
          <p:cNvSpPr txBox="1"/>
          <p:nvPr/>
        </p:nvSpPr>
        <p:spPr>
          <a:xfrm>
            <a:off x="1861919" y="95081"/>
            <a:ext cx="685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10A20DB6-12EB-4F04-A6FF-997A6113E513}"/>
              </a:ext>
            </a:extLst>
          </p:cNvPr>
          <p:cNvGrpSpPr/>
          <p:nvPr/>
        </p:nvGrpSpPr>
        <p:grpSpPr>
          <a:xfrm>
            <a:off x="751633" y="1766656"/>
            <a:ext cx="4387053" cy="2714348"/>
            <a:chOff x="3912090" y="1766656"/>
            <a:chExt cx="4387053" cy="2714348"/>
          </a:xfrm>
        </p:grpSpPr>
        <p:sp>
          <p:nvSpPr>
            <p:cNvPr id="4" name="椭圆 3">
              <a:extLst>
                <a:ext uri="{FF2B5EF4-FFF2-40B4-BE49-F238E27FC236}">
                  <a16:creationId xmlns:a16="http://schemas.microsoft.com/office/drawing/2014/main" id="{81F112F9-06ED-4DAE-84E1-FDEA3F6DCB12}"/>
                </a:ext>
              </a:extLst>
            </p:cNvPr>
            <p:cNvSpPr/>
            <p:nvPr/>
          </p:nvSpPr>
          <p:spPr>
            <a:xfrm>
              <a:off x="3912090" y="2376996"/>
              <a:ext cx="2104008" cy="210400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椭圆 7">
              <a:extLst>
                <a:ext uri="{FF2B5EF4-FFF2-40B4-BE49-F238E27FC236}">
                  <a16:creationId xmlns:a16="http://schemas.microsoft.com/office/drawing/2014/main" id="{38A2D1D7-1E81-4AA7-8CC4-FFF89E79078E}"/>
                </a:ext>
              </a:extLst>
            </p:cNvPr>
            <p:cNvSpPr/>
            <p:nvPr/>
          </p:nvSpPr>
          <p:spPr>
            <a:xfrm>
              <a:off x="6195135" y="2376996"/>
              <a:ext cx="2104008" cy="210400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0DA0F723-0D08-44CA-B64A-B52EC131F81B}"/>
                </a:ext>
              </a:extLst>
            </p:cNvPr>
            <p:cNvSpPr txBox="1"/>
            <p:nvPr/>
          </p:nvSpPr>
          <p:spPr>
            <a:xfrm>
              <a:off x="4707383" y="1766656"/>
              <a:ext cx="27772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hABE7.10n/GhABE7.10d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7AFD5904-0FC9-4632-846C-BF2DF635347E}"/>
                </a:ext>
              </a:extLst>
            </p:cNvPr>
            <p:cNvSpPr txBox="1"/>
            <p:nvPr/>
          </p:nvSpPr>
          <p:spPr>
            <a:xfrm>
              <a:off x="4227990" y="2971346"/>
              <a:ext cx="166012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-</a:t>
              </a:r>
              <a:r>
                <a:rPr lang="en-US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Finder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C55BC27E-9391-4CDF-8DE0-863CA20888CF}"/>
                </a:ext>
              </a:extLst>
            </p:cNvPr>
            <p:cNvSpPr txBox="1"/>
            <p:nvPr/>
          </p:nvSpPr>
          <p:spPr>
            <a:xfrm>
              <a:off x="4694434" y="3581686"/>
              <a:ext cx="53931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91</a:t>
              </a: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B914073-CCA1-44DF-89BE-72AF6FCFA2E8}"/>
                </a:ext>
              </a:extLst>
            </p:cNvPr>
            <p:cNvSpPr txBox="1"/>
            <p:nvPr/>
          </p:nvSpPr>
          <p:spPr>
            <a:xfrm>
              <a:off x="6933460" y="2971346"/>
              <a:ext cx="12376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GS</a:t>
              </a: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DB19D46-794A-4A04-B9FE-7BAC70798C52}"/>
                </a:ext>
              </a:extLst>
            </p:cNvPr>
            <p:cNvSpPr txBox="1"/>
            <p:nvPr/>
          </p:nvSpPr>
          <p:spPr>
            <a:xfrm>
              <a:off x="6977851" y="3581686"/>
              <a:ext cx="6680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290</a:t>
              </a: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D0A935A7-57A7-4C3E-86DA-C4A997062C18}"/>
              </a:ext>
            </a:extLst>
          </p:cNvPr>
          <p:cNvSpPr txBox="1"/>
          <p:nvPr/>
        </p:nvSpPr>
        <p:spPr>
          <a:xfrm>
            <a:off x="0" y="6397625"/>
            <a:ext cx="30346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5</a:t>
            </a: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3E063E13-2E52-4D41-B114-58E6BEB35B1F}"/>
              </a:ext>
            </a:extLst>
          </p:cNvPr>
          <p:cNvGrpSpPr/>
          <p:nvPr/>
        </p:nvGrpSpPr>
        <p:grpSpPr>
          <a:xfrm>
            <a:off x="6948258" y="1766656"/>
            <a:ext cx="4387053" cy="2714348"/>
            <a:chOff x="3912090" y="1766656"/>
            <a:chExt cx="4387053" cy="2714348"/>
          </a:xfrm>
        </p:grpSpPr>
        <p:sp>
          <p:nvSpPr>
            <p:cNvPr id="16" name="椭圆 15">
              <a:extLst>
                <a:ext uri="{FF2B5EF4-FFF2-40B4-BE49-F238E27FC236}">
                  <a16:creationId xmlns:a16="http://schemas.microsoft.com/office/drawing/2014/main" id="{AB6AA431-9D0C-4267-AB1F-BA12ECDC3C4B}"/>
                </a:ext>
              </a:extLst>
            </p:cNvPr>
            <p:cNvSpPr/>
            <p:nvPr/>
          </p:nvSpPr>
          <p:spPr>
            <a:xfrm>
              <a:off x="3912090" y="2376996"/>
              <a:ext cx="2104008" cy="210400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椭圆 17">
              <a:extLst>
                <a:ext uri="{FF2B5EF4-FFF2-40B4-BE49-F238E27FC236}">
                  <a16:creationId xmlns:a16="http://schemas.microsoft.com/office/drawing/2014/main" id="{615D9BFE-E30E-4AF6-9C3E-F1873B44B0E5}"/>
                </a:ext>
              </a:extLst>
            </p:cNvPr>
            <p:cNvSpPr/>
            <p:nvPr/>
          </p:nvSpPr>
          <p:spPr>
            <a:xfrm>
              <a:off x="6195135" y="2376996"/>
              <a:ext cx="2104008" cy="2104008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05BF013-D086-4C83-B668-77F859E87C56}"/>
                </a:ext>
              </a:extLst>
            </p:cNvPr>
            <p:cNvSpPr txBox="1"/>
            <p:nvPr/>
          </p:nvSpPr>
          <p:spPr>
            <a:xfrm>
              <a:off x="4707383" y="1766656"/>
              <a:ext cx="27772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hABE7.10n/GhABE7.10d</a:t>
              </a: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6A383A8B-0FF8-4389-986C-A493E59A71EC}"/>
                </a:ext>
              </a:extLst>
            </p:cNvPr>
            <p:cNvSpPr txBox="1"/>
            <p:nvPr/>
          </p:nvSpPr>
          <p:spPr>
            <a:xfrm>
              <a:off x="4227990" y="2971346"/>
              <a:ext cx="166012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-</a:t>
              </a:r>
              <a:r>
                <a:rPr lang="en-US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Finder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0CC2266-E7F0-40C8-9585-971948D3AE53}"/>
                </a:ext>
              </a:extLst>
            </p:cNvPr>
            <p:cNvSpPr txBox="1"/>
            <p:nvPr/>
          </p:nvSpPr>
          <p:spPr>
            <a:xfrm>
              <a:off x="4694434" y="3581686"/>
              <a:ext cx="53931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91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C87C903-060A-438F-9FEF-E3B9B214B74E}"/>
                </a:ext>
              </a:extLst>
            </p:cNvPr>
            <p:cNvSpPr txBox="1"/>
            <p:nvPr/>
          </p:nvSpPr>
          <p:spPr>
            <a:xfrm>
              <a:off x="6755908" y="2971346"/>
              <a:ext cx="12376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seq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B3F9D60-A005-4A76-BA16-939F92B25875}"/>
                </a:ext>
              </a:extLst>
            </p:cNvPr>
            <p:cNvSpPr txBox="1"/>
            <p:nvPr/>
          </p:nvSpPr>
          <p:spPr>
            <a:xfrm>
              <a:off x="6977851" y="3581686"/>
              <a:ext cx="6680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26</a:t>
              </a: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DD0B4400-1FA5-400F-B16F-55423920A89E}"/>
              </a:ext>
            </a:extLst>
          </p:cNvPr>
          <p:cNvSpPr txBox="1"/>
          <p:nvPr/>
        </p:nvSpPr>
        <p:spPr>
          <a:xfrm>
            <a:off x="380038" y="13973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5F41FD8-9BF9-4A80-BECB-037D71D241B0}"/>
              </a:ext>
            </a:extLst>
          </p:cNvPr>
          <p:cNvSpPr txBox="1"/>
          <p:nvPr/>
        </p:nvSpPr>
        <p:spPr>
          <a:xfrm>
            <a:off x="6727685" y="139732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367746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86E0FFC-E7B0-4D6D-AA9B-D96CAD72C4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54" y="693635"/>
            <a:ext cx="11518773" cy="547073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F0C418A-36BD-4C5F-A1CB-71C65BB68925}"/>
              </a:ext>
            </a:extLst>
          </p:cNvPr>
          <p:cNvSpPr txBox="1"/>
          <p:nvPr/>
        </p:nvSpPr>
        <p:spPr>
          <a:xfrm>
            <a:off x="0" y="6397625"/>
            <a:ext cx="29651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2385984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566"/>
          <a:stretch/>
        </p:blipFill>
        <p:spPr>
          <a:xfrm>
            <a:off x="-1" y="338061"/>
            <a:ext cx="12161520" cy="99748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/>
          <a:srcRect l="1209"/>
          <a:stretch/>
        </p:blipFill>
        <p:spPr>
          <a:xfrm>
            <a:off x="-2" y="3294922"/>
            <a:ext cx="12161520" cy="1119718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-2" y="3000039"/>
            <a:ext cx="1544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spc="200" noProof="1">
                <a:solidFill>
                  <a:srgbClr val="FF0000"/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7.10d-15-</a:t>
            </a:r>
            <a:r>
              <a:rPr lang="en-US" altLang="zh-CN" sz="1600" b="1" spc="200" dirty="0">
                <a:solidFill>
                  <a:srgbClr val="FF0000"/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1</a:t>
            </a:r>
            <a:endParaRPr lang="zh-CN" altLang="en-US" sz="1600" b="1" spc="200" dirty="0">
              <a:solidFill>
                <a:srgbClr val="FF0000"/>
              </a:solidFill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695524" y="40337"/>
            <a:ext cx="685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箭头连接符 19"/>
          <p:cNvCxnSpPr>
            <a:cxnSpLocks/>
          </p:cNvCxnSpPr>
          <p:nvPr/>
        </p:nvCxnSpPr>
        <p:spPr>
          <a:xfrm>
            <a:off x="5029243" y="261868"/>
            <a:ext cx="0" cy="23951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4872997" y="-25121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B9C979E-C51F-46BA-A8D8-74E67FC23694}"/>
              </a:ext>
            </a:extLst>
          </p:cNvPr>
          <p:cNvSpPr txBox="1"/>
          <p:nvPr/>
        </p:nvSpPr>
        <p:spPr>
          <a:xfrm>
            <a:off x="-1" y="6397625"/>
            <a:ext cx="29828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7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0CF18C3F-C6CD-449A-895F-0FF6A9B8F31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498"/>
          <a:stretch/>
        </p:blipFill>
        <p:spPr>
          <a:xfrm>
            <a:off x="0" y="4700422"/>
            <a:ext cx="11814048" cy="159217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95286D96-9FC8-4734-9799-9F26FE64058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864"/>
          <a:stretch/>
        </p:blipFill>
        <p:spPr>
          <a:xfrm>
            <a:off x="0" y="1512299"/>
            <a:ext cx="11814048" cy="1397269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1728460" y="423359"/>
            <a:ext cx="620099" cy="5869239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标题 1">
            <a:extLst>
              <a:ext uri="{FF2B5EF4-FFF2-40B4-BE49-F238E27FC236}">
                <a16:creationId xmlns:a16="http://schemas.microsoft.com/office/drawing/2014/main" id="{B9F5547E-6EEB-43C2-90A5-0923F43254C0}"/>
              </a:ext>
            </a:extLst>
          </p:cNvPr>
          <p:cNvSpPr txBox="1">
            <a:spLocks/>
          </p:cNvSpPr>
          <p:nvPr/>
        </p:nvSpPr>
        <p:spPr>
          <a:xfrm>
            <a:off x="-2" y="1189090"/>
            <a:ext cx="1273874" cy="5433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.10n-1-T0</a:t>
            </a:r>
            <a:endParaRPr lang="zh-CN" altLang="en-US" sz="1600" b="1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6">
            <a:extLst>
              <a:ext uri="{FF2B5EF4-FFF2-40B4-BE49-F238E27FC236}">
                <a16:creationId xmlns:a16="http://schemas.microsoft.com/office/drawing/2014/main" id="{D07F3476-A676-4EDB-ADC2-17C4BC385FFF}"/>
              </a:ext>
            </a:extLst>
          </p:cNvPr>
          <p:cNvSpPr txBox="1"/>
          <p:nvPr/>
        </p:nvSpPr>
        <p:spPr>
          <a:xfrm>
            <a:off x="22237" y="4380447"/>
            <a:ext cx="15224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spc="200" noProof="1">
                <a:solidFill>
                  <a:srgbClr val="FF0000"/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7.10d-15-</a:t>
            </a:r>
            <a:r>
              <a:rPr lang="en-US" altLang="zh-CN" sz="1600" b="1" spc="200" dirty="0">
                <a:solidFill>
                  <a:srgbClr val="FF0000"/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0</a:t>
            </a:r>
            <a:endParaRPr lang="zh-CN" altLang="en-US" sz="1600" b="1" spc="200" dirty="0">
              <a:solidFill>
                <a:srgbClr val="FF0000"/>
              </a:solidFill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91" y="125001"/>
            <a:ext cx="1273874" cy="435828"/>
          </a:xfrm>
        </p:spPr>
        <p:txBody>
          <a:bodyPr>
            <a:normAutofit/>
          </a:bodyPr>
          <a:lstStyle/>
          <a:p>
            <a:r>
              <a:rPr lang="en-US" altLang="zh-CN" sz="16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.10n-1-T1</a:t>
            </a:r>
            <a:endParaRPr lang="zh-CN" altLang="en-US" sz="1600" b="1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DF1DBC16-8527-44B2-B1C0-8ED9467B8DC5}"/>
              </a:ext>
            </a:extLst>
          </p:cNvPr>
          <p:cNvCxnSpPr>
            <a:cxnSpLocks/>
          </p:cNvCxnSpPr>
          <p:nvPr/>
        </p:nvCxnSpPr>
        <p:spPr>
          <a:xfrm>
            <a:off x="5961454" y="286989"/>
            <a:ext cx="0" cy="23951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D967754C-03F5-4410-A942-C9E05FD95039}"/>
              </a:ext>
            </a:extLst>
          </p:cNvPr>
          <p:cNvSpPr txBox="1"/>
          <p:nvPr/>
        </p:nvSpPr>
        <p:spPr>
          <a:xfrm>
            <a:off x="5805208" y="0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92649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77B16984-5398-4782-BB59-4661673EED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394" y="4224951"/>
            <a:ext cx="12171212" cy="263304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4FF5933E-1FD3-47F7-951F-581BA58FF549}"/>
              </a:ext>
            </a:extLst>
          </p:cNvPr>
          <p:cNvSpPr txBox="1"/>
          <p:nvPr/>
        </p:nvSpPr>
        <p:spPr>
          <a:xfrm>
            <a:off x="0" y="6396334"/>
            <a:ext cx="110083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A4F1E57-2A86-4DF0-A2F4-94D1CE6568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75633" y="1602957"/>
            <a:ext cx="1889682" cy="265602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1683EA8-0F99-4698-B572-F8CBDFC5159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49720" y="1602956"/>
            <a:ext cx="1918242" cy="2656026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FC9AD338-006A-4D2A-ACAC-6FD77F20CCB6}"/>
              </a:ext>
            </a:extLst>
          </p:cNvPr>
          <p:cNvSpPr txBox="1"/>
          <p:nvPr/>
        </p:nvSpPr>
        <p:spPr>
          <a:xfrm>
            <a:off x="3657376" y="500499"/>
            <a:ext cx="400110" cy="65400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F6D5365-9390-4A2D-AE37-8A48299D1E34}"/>
              </a:ext>
            </a:extLst>
          </p:cNvPr>
          <p:cNvSpPr txBox="1"/>
          <p:nvPr/>
        </p:nvSpPr>
        <p:spPr>
          <a:xfrm>
            <a:off x="4405822" y="500499"/>
            <a:ext cx="677108" cy="74839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65B1362-255A-4390-B64A-139F1F5D3B90}"/>
              </a:ext>
            </a:extLst>
          </p:cNvPr>
          <p:cNvSpPr txBox="1"/>
          <p:nvPr/>
        </p:nvSpPr>
        <p:spPr>
          <a:xfrm>
            <a:off x="4161433" y="500499"/>
            <a:ext cx="400110" cy="74839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F2606F7-3999-4E2F-A4FC-64A970241281}"/>
              </a:ext>
            </a:extLst>
          </p:cNvPr>
          <p:cNvSpPr txBox="1"/>
          <p:nvPr/>
        </p:nvSpPr>
        <p:spPr>
          <a:xfrm>
            <a:off x="5131076" y="500498"/>
            <a:ext cx="400110" cy="123064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10n-1-T1-1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3002832-21B2-4563-9364-57BE7294DE7B}"/>
              </a:ext>
            </a:extLst>
          </p:cNvPr>
          <p:cNvSpPr txBox="1"/>
          <p:nvPr/>
        </p:nvSpPr>
        <p:spPr>
          <a:xfrm>
            <a:off x="5850831" y="500499"/>
            <a:ext cx="400110" cy="65400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D7C7DBA-CB63-4A75-B24F-FC70C4E21432}"/>
              </a:ext>
            </a:extLst>
          </p:cNvPr>
          <p:cNvSpPr txBox="1"/>
          <p:nvPr/>
        </p:nvSpPr>
        <p:spPr>
          <a:xfrm>
            <a:off x="6599278" y="500499"/>
            <a:ext cx="677108" cy="74839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7520B15-B9AC-45E3-9EC9-25CC2F5716F4}"/>
              </a:ext>
            </a:extLst>
          </p:cNvPr>
          <p:cNvSpPr txBox="1"/>
          <p:nvPr/>
        </p:nvSpPr>
        <p:spPr>
          <a:xfrm>
            <a:off x="6354888" y="500499"/>
            <a:ext cx="400110" cy="74839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8B8734A-7AEF-4892-A631-BA2F5028802A}"/>
              </a:ext>
            </a:extLst>
          </p:cNvPr>
          <p:cNvSpPr txBox="1"/>
          <p:nvPr/>
        </p:nvSpPr>
        <p:spPr>
          <a:xfrm>
            <a:off x="7324532" y="500498"/>
            <a:ext cx="400110" cy="112411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10n-1-T1-1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FEAB599-8F9C-4759-81DD-D66351C880E8}"/>
              </a:ext>
            </a:extLst>
          </p:cNvPr>
          <p:cNvSpPr txBox="1"/>
          <p:nvPr/>
        </p:nvSpPr>
        <p:spPr>
          <a:xfrm>
            <a:off x="3717868" y="97654"/>
            <a:ext cx="1847447" cy="296835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PT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Ⅱ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10A292C-F4F5-460B-A4E8-2D4CF11DA45A}"/>
              </a:ext>
            </a:extLst>
          </p:cNvPr>
          <p:cNvSpPr txBox="1"/>
          <p:nvPr/>
        </p:nvSpPr>
        <p:spPr>
          <a:xfrm>
            <a:off x="5849720" y="97654"/>
            <a:ext cx="1918242" cy="296835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N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DA2B808-178D-4F5D-9472-1CFA2D44E349}"/>
              </a:ext>
            </a:extLst>
          </p:cNvPr>
          <p:cNvSpPr txBox="1"/>
          <p:nvPr/>
        </p:nvSpPr>
        <p:spPr>
          <a:xfrm>
            <a:off x="2923543" y="97654"/>
            <a:ext cx="516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F8EC122-5C91-4D6A-AF5E-AF2ADFC8A240}"/>
              </a:ext>
            </a:extLst>
          </p:cNvPr>
          <p:cNvSpPr txBox="1"/>
          <p:nvPr/>
        </p:nvSpPr>
        <p:spPr>
          <a:xfrm>
            <a:off x="39268" y="3763312"/>
            <a:ext cx="516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834783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75E8DC8-173F-4483-BB13-B0CCA5ECB4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068496" y="43136"/>
            <a:ext cx="9698139" cy="677047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DD141B7-7E6D-473C-945D-4DD2EB507558}"/>
              </a:ext>
            </a:extLst>
          </p:cNvPr>
          <p:cNvSpPr txBox="1"/>
          <p:nvPr/>
        </p:nvSpPr>
        <p:spPr>
          <a:xfrm>
            <a:off x="0" y="6351943"/>
            <a:ext cx="10741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Times New Roman" panose="02020603050405020304" charset="0"/>
                <a:cs typeface="Times New Roman" panose="02020603050405020304" charset="0"/>
              </a:rPr>
              <a:t>Fig. S9</a:t>
            </a:r>
          </a:p>
        </p:txBody>
      </p:sp>
    </p:spTree>
    <p:extLst>
      <p:ext uri="{BB962C8B-B14F-4D97-AF65-F5344CB8AC3E}">
        <p14:creationId xmlns:p14="http://schemas.microsoft.com/office/powerpoint/2010/main" val="2033155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0</TotalTime>
  <Words>73</Words>
  <Application>Microsoft Office PowerPoint</Application>
  <PresentationFormat>宽屏</PresentationFormat>
  <Paragraphs>48</Paragraphs>
  <Slides>10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7.10n-1-T1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 Zhongping</dc:creator>
  <cp:lastModifiedBy>Xu Zhongping</cp:lastModifiedBy>
  <cp:revision>69</cp:revision>
  <dcterms:created xsi:type="dcterms:W3CDTF">2020-06-25T08:56:14Z</dcterms:created>
  <dcterms:modified xsi:type="dcterms:W3CDTF">2021-12-18T14:08:40Z</dcterms:modified>
</cp:coreProperties>
</file>